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notesSlides/notesSlide6.xml" ContentType="application/vnd.openxmlformats-officedocument.presentationml.notes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7">
  <p:sldMasterIdLst>
    <p:sldMasterId id="2147483648" r:id="rId1"/>
  </p:sldMasterIdLst>
  <p:notesMasterIdLst>
    <p:notesMasterId r:id="rId8"/>
  </p:notesMasterIdLst>
  <p:sldIdLst>
    <p:sldId id="268" r:id="rId2"/>
    <p:sldId id="261" r:id="rId3"/>
    <p:sldId id="257" r:id="rId4"/>
    <p:sldId id="269" r:id="rId5"/>
    <p:sldId id="260" r:id="rId6"/>
    <p:sldId id="265" r:id="rId7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MC Editor" initials="E" lastIdx="12" clrIdx="0">
    <p:extLst/>
  </p:cmAuthor>
  <p:cmAuthor id="2" name="QA Editor" initials="QA Edit" lastIdx="1" clrIdx="1"/>
  <p:cmAuthor id="3" name="user" initials="u" lastIdx="12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80" autoAdjust="0"/>
    <p:restoredTop sz="90024" autoAdjust="0"/>
  </p:normalViewPr>
  <p:slideViewPr>
    <p:cSldViewPr>
      <p:cViewPr varScale="1">
        <p:scale>
          <a:sx n="66" d="100"/>
          <a:sy n="66" d="100"/>
        </p:scale>
        <p:origin x="-120" y="-810"/>
      </p:cViewPr>
      <p:guideLst>
        <p:guide orient="horz" pos="2160"/>
        <p:guide pos="288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E71730-4184-4814-8AFA-2AE20727F188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6F93B9-5B34-4103-BBF1-47593CAF981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508605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237116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1625434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935557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8587944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6F93B9-5B34-4103-BBF1-47593CAF981B}" type="slidenum">
              <a:rPr kumimoji="1" lang="ja-JP" altLang="en-US" smtClean="0"/>
              <a:pPr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985531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8C9A7-A7FB-4BB1-BE9E-6D5C07E7B173}" type="datetimeFigureOut">
              <a:rPr kumimoji="1" lang="ja-JP" altLang="en-US" smtClean="0"/>
              <a:pPr/>
              <a:t>2019/11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A1626-26EC-4CCB-B308-907F7C95BCB6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14"/>
          <p:cNvSpPr>
            <a:spLocks noChangeArrowheads="1"/>
          </p:cNvSpPr>
          <p:nvPr/>
        </p:nvSpPr>
        <p:spPr bwMode="auto">
          <a:xfrm>
            <a:off x="2818936" y="737500"/>
            <a:ext cx="5929527" cy="903288"/>
          </a:xfrm>
          <a:prstGeom prst="rect">
            <a:avLst/>
          </a:prstGeom>
          <a:noFill/>
          <a:ln w="7620">
            <a:solidFill>
              <a:srgbClr val="000000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kumimoji="0" lang="ja-JP" altLang="ja-JP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　</a:t>
            </a:r>
            <a:r>
              <a:rPr kumimoji="0" lang="ja-JP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　</a:t>
            </a:r>
            <a:endParaRPr kumimoji="0" lang="ja-JP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388"/>
          <p:cNvSpPr>
            <a:spLocks noChangeArrowheads="1"/>
          </p:cNvSpPr>
          <p:nvPr/>
        </p:nvSpPr>
        <p:spPr bwMode="auto">
          <a:xfrm>
            <a:off x="2818937" y="4797152"/>
            <a:ext cx="1211263" cy="35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ate pregnancy</a:t>
            </a: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389"/>
          <p:cNvSpPr>
            <a:spLocks noChangeArrowheads="1"/>
          </p:cNvSpPr>
          <p:nvPr/>
        </p:nvSpPr>
        <p:spPr bwMode="auto">
          <a:xfrm>
            <a:off x="6245251" y="4725144"/>
            <a:ext cx="1063053" cy="571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ne-month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postpartum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heck-up</a:t>
            </a: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390"/>
          <p:cNvSpPr>
            <a:spLocks noChangeArrowheads="1"/>
          </p:cNvSpPr>
          <p:nvPr/>
        </p:nvSpPr>
        <p:spPr bwMode="auto">
          <a:xfrm>
            <a:off x="3995936" y="4202162"/>
            <a:ext cx="1088919" cy="23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ildbirth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395"/>
          <p:cNvSpPr>
            <a:spLocks noChangeArrowheads="1"/>
          </p:cNvSpPr>
          <p:nvPr/>
        </p:nvSpPr>
        <p:spPr bwMode="auto">
          <a:xfrm>
            <a:off x="698500" y="1489075"/>
            <a:ext cx="114300" cy="160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Rectangle 396"/>
          <p:cNvSpPr>
            <a:spLocks noChangeArrowheads="1"/>
          </p:cNvSpPr>
          <p:nvPr/>
        </p:nvSpPr>
        <p:spPr bwMode="auto">
          <a:xfrm>
            <a:off x="1484828" y="1696248"/>
            <a:ext cx="1112837" cy="741363"/>
          </a:xfrm>
          <a:prstGeom prst="rect">
            <a:avLst/>
          </a:prstGeom>
          <a:noFill/>
          <a:ln w="7620">
            <a:solidFill>
              <a:srgbClr val="000000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nrollmen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andom allocation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404"/>
          <p:cNvSpPr>
            <a:spLocks noChangeArrowheads="1"/>
          </p:cNvSpPr>
          <p:nvPr/>
        </p:nvSpPr>
        <p:spPr bwMode="auto">
          <a:xfrm>
            <a:off x="4826000" y="1196975"/>
            <a:ext cx="44450" cy="160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System"/>
              </a:rPr>
              <a:t> 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406"/>
          <p:cNvSpPr>
            <a:spLocks noChangeArrowheads="1"/>
          </p:cNvSpPr>
          <p:nvPr/>
        </p:nvSpPr>
        <p:spPr bwMode="auto">
          <a:xfrm>
            <a:off x="2818937" y="2082977"/>
            <a:ext cx="5929527" cy="1639040"/>
          </a:xfrm>
          <a:prstGeom prst="rect">
            <a:avLst/>
          </a:prstGeom>
          <a:noFill/>
          <a:ln w="7620">
            <a:solidFill>
              <a:srgbClr val="000000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group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addition to standard care (group guidance), the intervention group received individual education during late pregnancy and a one-month postpartum check-up </a:t>
            </a:r>
            <a:r>
              <a:rPr kumimoji="0" lang="ja-JP" altLang="ja-JP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</a:t>
            </a:r>
            <a:endParaRPr kumimoji="0" lang="ja-JP" altLang="en-U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Freeform 412"/>
          <p:cNvSpPr>
            <a:spLocks/>
          </p:cNvSpPr>
          <p:nvPr/>
        </p:nvSpPr>
        <p:spPr bwMode="auto">
          <a:xfrm>
            <a:off x="1968725" y="2454149"/>
            <a:ext cx="829066" cy="507415"/>
          </a:xfrm>
          <a:custGeom>
            <a:avLst/>
            <a:gdLst>
              <a:gd name="T0" fmla="*/ 945515 w 855"/>
              <a:gd name="T1" fmla="*/ 390525 h 842"/>
              <a:gd name="T2" fmla="*/ 945515 w 855"/>
              <a:gd name="T3" fmla="*/ 389597 h 842"/>
              <a:gd name="T4" fmla="*/ 945515 w 855"/>
              <a:gd name="T5" fmla="*/ 388206 h 842"/>
              <a:gd name="T6" fmla="*/ 945515 w 855"/>
              <a:gd name="T7" fmla="*/ 387278 h 842"/>
              <a:gd name="T8" fmla="*/ 9953 w 855"/>
              <a:gd name="T9" fmla="*/ 0 h 842"/>
              <a:gd name="T10" fmla="*/ 4423 w 855"/>
              <a:gd name="T11" fmla="*/ 928 h 842"/>
              <a:gd name="T12" fmla="*/ 0 w 855"/>
              <a:gd name="T13" fmla="*/ 2319 h 842"/>
              <a:gd name="T14" fmla="*/ 0 w 855"/>
              <a:gd name="T15" fmla="*/ 3247 h 842"/>
              <a:gd name="T16" fmla="*/ 4423 w 855"/>
              <a:gd name="T17" fmla="*/ 4638 h 842"/>
              <a:gd name="T18" fmla="*/ 945515 w 855"/>
              <a:gd name="T19" fmla="*/ 390525 h 842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855" h="842">
                <a:moveTo>
                  <a:pt x="855" y="842"/>
                </a:moveTo>
                <a:lnTo>
                  <a:pt x="855" y="840"/>
                </a:lnTo>
                <a:lnTo>
                  <a:pt x="855" y="837"/>
                </a:lnTo>
                <a:lnTo>
                  <a:pt x="855" y="835"/>
                </a:lnTo>
                <a:lnTo>
                  <a:pt x="9" y="0"/>
                </a:lnTo>
                <a:lnTo>
                  <a:pt x="4" y="2"/>
                </a:lnTo>
                <a:lnTo>
                  <a:pt x="0" y="5"/>
                </a:lnTo>
                <a:lnTo>
                  <a:pt x="0" y="7"/>
                </a:lnTo>
                <a:lnTo>
                  <a:pt x="4" y="10"/>
                </a:lnTo>
                <a:lnTo>
                  <a:pt x="855" y="842"/>
                </a:lnTo>
                <a:close/>
              </a:path>
            </a:pathLst>
          </a:custGeom>
          <a:solidFill>
            <a:srgbClr val="000000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Rectangle 415"/>
          <p:cNvSpPr>
            <a:spLocks noChangeArrowheads="1"/>
          </p:cNvSpPr>
          <p:nvPr/>
        </p:nvSpPr>
        <p:spPr bwMode="auto">
          <a:xfrm>
            <a:off x="7687510" y="1082700"/>
            <a:ext cx="1036587" cy="546100"/>
          </a:xfrm>
          <a:prstGeom prst="rect">
            <a:avLst/>
          </a:prstGeom>
          <a:noFill/>
          <a:ln w="762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ost-study</a:t>
            </a: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416"/>
          <p:cNvSpPr>
            <a:spLocks noChangeArrowheads="1"/>
          </p:cNvSpPr>
          <p:nvPr/>
        </p:nvSpPr>
        <p:spPr bwMode="auto">
          <a:xfrm>
            <a:off x="159043" y="1168146"/>
            <a:ext cx="1258595" cy="498389"/>
          </a:xfrm>
          <a:prstGeom prst="rect">
            <a:avLst/>
          </a:prstGeom>
          <a:noFill/>
          <a:ln w="762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ed consent obtained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417"/>
          <p:cNvSpPr>
            <a:spLocks noChangeArrowheads="1"/>
          </p:cNvSpPr>
          <p:nvPr/>
        </p:nvSpPr>
        <p:spPr bwMode="auto">
          <a:xfrm>
            <a:off x="677863" y="4797152"/>
            <a:ext cx="1479550" cy="442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during gestational weeks 29–33</a:t>
            </a: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420"/>
          <p:cNvSpPr>
            <a:spLocks noChangeArrowheads="1"/>
          </p:cNvSpPr>
          <p:nvPr/>
        </p:nvSpPr>
        <p:spPr bwMode="auto">
          <a:xfrm>
            <a:off x="7523099" y="4202063"/>
            <a:ext cx="1455738" cy="23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ree months of age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427"/>
          <p:cNvSpPr>
            <a:spLocks noChangeArrowheads="1"/>
          </p:cNvSpPr>
          <p:nvPr/>
        </p:nvSpPr>
        <p:spPr bwMode="auto">
          <a:xfrm>
            <a:off x="2818937" y="3155279"/>
            <a:ext cx="1104991" cy="566737"/>
          </a:xfrm>
          <a:prstGeom prst="rect">
            <a:avLst/>
          </a:prstGeom>
          <a:ln>
            <a:headEnd/>
            <a:tailEnd/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dividual education</a:t>
            </a:r>
            <a:r>
              <a:rPr kumimoji="0" lang="ja-JP" altLang="en-US" sz="12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kumimoji="0" lang="en-US" altLang="ja-JP" sz="1200" dirty="0">
              <a:solidFill>
                <a:schemeClr val="tx1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429"/>
          <p:cNvSpPr>
            <a:spLocks noChangeArrowheads="1"/>
          </p:cNvSpPr>
          <p:nvPr/>
        </p:nvSpPr>
        <p:spPr bwMode="auto">
          <a:xfrm>
            <a:off x="6154515" y="3148082"/>
            <a:ext cx="793749" cy="566737"/>
          </a:xfrm>
          <a:prstGeom prst="rect">
            <a:avLst/>
          </a:prstGeom>
          <a:ln>
            <a:headEnd/>
            <a:tailEnd/>
          </a:ln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dividual education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Rectangle 430"/>
          <p:cNvSpPr>
            <a:spLocks noChangeArrowheads="1"/>
          </p:cNvSpPr>
          <p:nvPr/>
        </p:nvSpPr>
        <p:spPr bwMode="auto">
          <a:xfrm>
            <a:off x="7759855" y="3148082"/>
            <a:ext cx="964242" cy="577850"/>
          </a:xfrm>
          <a:prstGeom prst="rect">
            <a:avLst/>
          </a:prstGeom>
          <a:noFill/>
          <a:ln w="762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ost-study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431"/>
          <p:cNvSpPr>
            <a:spLocks noChangeArrowheads="1"/>
          </p:cNvSpPr>
          <p:nvPr/>
        </p:nvSpPr>
        <p:spPr bwMode="auto">
          <a:xfrm>
            <a:off x="172943" y="2225082"/>
            <a:ext cx="1090613" cy="479425"/>
          </a:xfrm>
          <a:prstGeom prst="rect">
            <a:avLst/>
          </a:prstGeom>
          <a:noFill/>
          <a:ln w="762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re-study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26"/>
          <p:cNvSpPr>
            <a:spLocks noChangeArrowheads="1"/>
          </p:cNvSpPr>
          <p:nvPr/>
        </p:nvSpPr>
        <p:spPr bwMode="auto">
          <a:xfrm>
            <a:off x="152400" y="1524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30" name="Rectangle 28"/>
          <p:cNvSpPr>
            <a:spLocks noChangeArrowheads="1"/>
          </p:cNvSpPr>
          <p:nvPr/>
        </p:nvSpPr>
        <p:spPr bwMode="auto">
          <a:xfrm>
            <a:off x="152400" y="6096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000" b="0" i="0" u="none" strike="noStrike" cap="none" normalizeH="0" baseline="0" bmk="_Toc369178759">
              <a:ln>
                <a:noFill/>
              </a:ln>
              <a:solidFill>
                <a:schemeClr val="tx1"/>
              </a:solidFill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bmk="_Toc369178759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　</a:t>
            </a:r>
            <a:endParaRPr kumimoji="0" lang="ja-JP" altLang="ja-JP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43"/>
          <p:cNvSpPr>
            <a:spLocks noChangeArrowheads="1"/>
          </p:cNvSpPr>
          <p:nvPr/>
        </p:nvSpPr>
        <p:spPr bwMode="auto">
          <a:xfrm>
            <a:off x="152400" y="6096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/>
            </a:r>
            <a:br>
              <a: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47"/>
          <p:cNvSpPr>
            <a:spLocks noChangeArrowheads="1"/>
          </p:cNvSpPr>
          <p:nvPr/>
        </p:nvSpPr>
        <p:spPr bwMode="auto">
          <a:xfrm>
            <a:off x="1119575" y="5616529"/>
            <a:ext cx="5121915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581025"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539750" algn="r"/>
                <a:tab pos="2700338" algn="ctr"/>
                <a:tab pos="5400675" algn="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　</a:t>
            </a:r>
            <a:endParaRPr kumimoji="0" lang="ja-JP" altLang="ja-JP" sz="700" dirty="0"/>
          </a:p>
          <a:p>
            <a:pPr lvl="0"/>
            <a:r>
              <a:rPr lang="en-US" altLang="ja-JP" sz="2400" b="1" dirty="0" smtClean="0"/>
              <a:t>Figure S1</a:t>
            </a:r>
            <a:r>
              <a:rPr lang="en-US" altLang="ja-JP" sz="2400" b="1" dirty="0" smtClean="0"/>
              <a:t>. </a:t>
            </a:r>
            <a:r>
              <a:rPr kumimoji="0" lang="en-US" altLang="ja-JP" sz="2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utline </a:t>
            </a:r>
            <a:r>
              <a:rPr kumimoji="0" lang="en-US" altLang="ja-JP" sz="2400" b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the study</a:t>
            </a:r>
            <a:endParaRPr kumimoji="0" lang="en-US" altLang="ja-JP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581025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39750" algn="r"/>
                <a:tab pos="2700338" algn="ctr"/>
                <a:tab pos="5400675" algn="r"/>
              </a:tabLst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" name="Rectangle 428"/>
          <p:cNvSpPr>
            <a:spLocks noChangeArrowheads="1"/>
          </p:cNvSpPr>
          <p:nvPr/>
        </p:nvSpPr>
        <p:spPr bwMode="auto">
          <a:xfrm>
            <a:off x="4293172" y="1058070"/>
            <a:ext cx="1142924" cy="566737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dash"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68686"/>
                  </a:outerShdw>
                </a:effectLst>
              </a14:hiddenEffects>
            </a:ext>
          </a:extLst>
        </p:spPr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group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uidance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are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8" name="Freeform 412"/>
          <p:cNvSpPr>
            <a:spLocks/>
          </p:cNvSpPr>
          <p:nvPr/>
        </p:nvSpPr>
        <p:spPr bwMode="auto">
          <a:xfrm flipV="1">
            <a:off x="2022475" y="1153941"/>
            <a:ext cx="796461" cy="512594"/>
          </a:xfrm>
          <a:custGeom>
            <a:avLst/>
            <a:gdLst>
              <a:gd name="T0" fmla="*/ 945515 w 855"/>
              <a:gd name="T1" fmla="*/ 390525 h 842"/>
              <a:gd name="T2" fmla="*/ 945515 w 855"/>
              <a:gd name="T3" fmla="*/ 389597 h 842"/>
              <a:gd name="T4" fmla="*/ 945515 w 855"/>
              <a:gd name="T5" fmla="*/ 388206 h 842"/>
              <a:gd name="T6" fmla="*/ 945515 w 855"/>
              <a:gd name="T7" fmla="*/ 387278 h 842"/>
              <a:gd name="T8" fmla="*/ 9953 w 855"/>
              <a:gd name="T9" fmla="*/ 0 h 842"/>
              <a:gd name="T10" fmla="*/ 4423 w 855"/>
              <a:gd name="T11" fmla="*/ 928 h 842"/>
              <a:gd name="T12" fmla="*/ 0 w 855"/>
              <a:gd name="T13" fmla="*/ 2319 h 842"/>
              <a:gd name="T14" fmla="*/ 0 w 855"/>
              <a:gd name="T15" fmla="*/ 3247 h 842"/>
              <a:gd name="T16" fmla="*/ 4423 w 855"/>
              <a:gd name="T17" fmla="*/ 4638 h 842"/>
              <a:gd name="T18" fmla="*/ 945515 w 855"/>
              <a:gd name="T19" fmla="*/ 390525 h 842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855" h="842">
                <a:moveTo>
                  <a:pt x="855" y="842"/>
                </a:moveTo>
                <a:lnTo>
                  <a:pt x="855" y="840"/>
                </a:lnTo>
                <a:lnTo>
                  <a:pt x="855" y="837"/>
                </a:lnTo>
                <a:lnTo>
                  <a:pt x="855" y="835"/>
                </a:lnTo>
                <a:lnTo>
                  <a:pt x="9" y="0"/>
                </a:lnTo>
                <a:lnTo>
                  <a:pt x="4" y="2"/>
                </a:lnTo>
                <a:lnTo>
                  <a:pt x="0" y="5"/>
                </a:lnTo>
                <a:lnTo>
                  <a:pt x="0" y="7"/>
                </a:lnTo>
                <a:lnTo>
                  <a:pt x="4" y="10"/>
                </a:lnTo>
                <a:lnTo>
                  <a:pt x="855" y="842"/>
                </a:lnTo>
                <a:close/>
              </a:path>
            </a:pathLst>
          </a:custGeom>
          <a:solidFill>
            <a:srgbClr val="000000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42" name="直線コネクタ 41"/>
          <p:cNvCxnSpPr/>
          <p:nvPr/>
        </p:nvCxnSpPr>
        <p:spPr>
          <a:xfrm>
            <a:off x="467544" y="4599019"/>
            <a:ext cx="77048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2411760" y="4437112"/>
            <a:ext cx="0" cy="2984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6588224" y="4437112"/>
            <a:ext cx="0" cy="2984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8172400" y="4437112"/>
            <a:ext cx="0" cy="2984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Rectangle 428"/>
          <p:cNvSpPr>
            <a:spLocks noChangeArrowheads="1"/>
          </p:cNvSpPr>
          <p:nvPr/>
        </p:nvSpPr>
        <p:spPr bwMode="auto">
          <a:xfrm>
            <a:off x="4336385" y="3148082"/>
            <a:ext cx="1142924" cy="566737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dash"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68686"/>
                  </a:outerShdw>
                </a:effectLst>
              </a14:hiddenEffects>
            </a:ext>
          </a:extLst>
        </p:spPr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group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uidance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are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33" name="直線コネクタ 32"/>
          <p:cNvCxnSpPr/>
          <p:nvPr/>
        </p:nvCxnSpPr>
        <p:spPr>
          <a:xfrm>
            <a:off x="4283968" y="4437112"/>
            <a:ext cx="0" cy="2984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7149446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44624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ja-JP" sz="2400" b="1" dirty="0" smtClean="0"/>
              <a:t>Table S1.</a:t>
            </a:r>
            <a:r>
              <a:rPr lang="en-US" altLang="ja-JP" sz="2400" dirty="0" smtClean="0"/>
              <a:t> </a:t>
            </a:r>
            <a:r>
              <a:rPr lang="en-US" altLang="ja-JP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ja-JP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</a:br>
            <a:r>
              <a:rPr lang="en-US" altLang="ja-JP" sz="2400" dirty="0">
                <a:latin typeface="Times New Roman"/>
                <a:ea typeface="ＭＳ 明朝"/>
              </a:rPr>
              <a:t>Questions for</a:t>
            </a:r>
            <a:r>
              <a:rPr lang="en-US" altLang="ja-JP" sz="2400" b="1" dirty="0">
                <a:latin typeface="Times New Roman"/>
                <a:ea typeface="ＭＳ 明朝"/>
              </a:rPr>
              <a:t> </a:t>
            </a:r>
            <a:r>
              <a:rPr lang="en-US" altLang="ja-JP" sz="2400" dirty="0">
                <a:latin typeface="Times New Roman" pitchFamily="18" charset="0"/>
                <a:cs typeface="Times New Roman" pitchFamily="18" charset="0"/>
              </a:rPr>
              <a:t>basic knowledge related to vaccination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コンテンツ プレースホル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299751801"/>
              </p:ext>
            </p:extLst>
          </p:nvPr>
        </p:nvGraphicFramePr>
        <p:xfrm>
          <a:off x="323528" y="1196752"/>
          <a:ext cx="8568952" cy="5176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56895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tement/Quest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65264">
                <a:tc>
                  <a:txBody>
                    <a:bodyPr/>
                    <a:lstStyle/>
                    <a:p>
                      <a:r>
                        <a:rPr kumimoji="1" lang="en-US" altLang="ja-JP" sz="1400" u="none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 There are some diseases that can be prevented with a vaccine and some diseases that can not be prevented with a </a:t>
                      </a:r>
                    </a:p>
                    <a:p>
                      <a:r>
                        <a:rPr kumimoji="1" lang="en-US" altLang="ja-JP" sz="1400" u="none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vaccine.</a:t>
                      </a:r>
                    </a:p>
                    <a:p>
                      <a:r>
                        <a:rPr kumimoji="1" lang="en-US" altLang="ja-JP" sz="1400" u="none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</a:t>
                      </a:r>
                      <a:endParaRPr kumimoji="1" lang="ja-JP" altLang="en-US" sz="1400" b="1" u="none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u="non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 A person will</a:t>
                      </a:r>
                      <a:r>
                        <a:rPr kumimoji="1" lang="en-US" altLang="ja-JP" sz="1400" u="none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not</a:t>
                      </a:r>
                      <a:r>
                        <a:rPr kumimoji="1" lang="en-US" altLang="ja-JP" sz="1400" u="non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be infected with a </a:t>
                      </a:r>
                      <a:r>
                        <a:rPr kumimoji="1" lang="en-US" altLang="ja-JP" sz="1400" u="none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sease</a:t>
                      </a:r>
                      <a:r>
                        <a:rPr kumimoji="1" lang="en-US" altLang="ja-JP" sz="1800" b="0" i="0" u="none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1" lang="en-US" altLang="ja-JP" sz="1400" u="none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f </a:t>
                      </a:r>
                      <a:r>
                        <a:rPr kumimoji="1" lang="en-US" altLang="ja-JP" sz="1400" u="none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y are immunized against it.</a:t>
                      </a:r>
                      <a:r>
                        <a:rPr kumimoji="1" lang="en-US" altLang="ja-JP" sz="1400" u="non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kumimoji="1" lang="ja-JP" altLang="en-US" sz="1400" b="1" u="none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33216">
                <a:tc>
                  <a:txBody>
                    <a:bodyPr/>
                    <a:lstStyle/>
                    <a:p>
                      <a:r>
                        <a:rPr kumimoji="1" lang="en-US" altLang="ja-JP" sz="1400" u="non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 </a:t>
                      </a:r>
                      <a:r>
                        <a:rPr kumimoji="1" lang="en-US" altLang="ja-JP" sz="1400" u="none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mmunity </a:t>
                      </a:r>
                      <a:r>
                        <a:rPr kumimoji="1" lang="en-US" altLang="ja-JP" sz="1400" u="non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gainst natural infections is safer than immunization. </a:t>
                      </a:r>
                      <a:endParaRPr kumimoji="1" lang="ja-JP" altLang="en-US" sz="1400" b="1" u="none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 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f a person does not receive vaccination and suffers from a disease that could have been prevented with a vaccine, 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</a:p>
                    <a:p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treatment 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 an early stage would prevent any sequela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 All vaccines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nly need to be administered once; there is no need to receive the same vaccine again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 Simultaneous inoculation speeds up acquisition of immunity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 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utine vaccines under the national immunization law can be administered at any time at the tax-payers’ expense </a:t>
                      </a:r>
                      <a:r>
                        <a:rPr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  <a:p>
                      <a:r>
                        <a:rPr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(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ree of charge)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 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f a person does not receive vaccination and suffers from a disease that could have been prevented with a vaccine,</a:t>
                      </a:r>
                      <a:r>
                        <a:rPr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no serious complication will occur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.</a:t>
                      </a:r>
                      <a:endParaRPr kumimoji="1" lang="ja-JP" altLang="en-US" sz="1400" b="1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 The first vaccination after birth should be administered at 2 months old of</a:t>
                      </a:r>
                      <a:r>
                        <a:rPr kumimoji="1" lang="en-US" altLang="ja-JP" sz="14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age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 After receiving a vaccination, it is necessary to observe the person’s condition for 15 to 30 minutes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ja-JP" sz="2800" b="1" dirty="0" smtClean="0"/>
              <a:t>Table S2.</a:t>
            </a:r>
            <a:r>
              <a:rPr lang="en-US" altLang="ja-JP" sz="2800" b="1" dirty="0">
                <a:latin typeface="Times New Roman"/>
                <a:ea typeface="ＭＳ 明朝"/>
              </a:rPr>
              <a:t/>
            </a:r>
            <a:br>
              <a:rPr lang="en-US" altLang="ja-JP" sz="2800" b="1" dirty="0">
                <a:latin typeface="Times New Roman"/>
                <a:ea typeface="ＭＳ 明朝"/>
              </a:rPr>
            </a:br>
            <a:r>
              <a:rPr lang="en-US" altLang="ja-JP" sz="2400" dirty="0">
                <a:latin typeface="Times New Roman"/>
                <a:ea typeface="ＭＳ 明朝"/>
              </a:rPr>
              <a:t>Questions for</a:t>
            </a:r>
            <a:r>
              <a:rPr lang="en-US" altLang="ja-JP" sz="2400" b="1" dirty="0">
                <a:latin typeface="Times New Roman"/>
                <a:ea typeface="ＭＳ 明朝"/>
              </a:rPr>
              <a:t>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 </a:t>
            </a:r>
            <a:r>
              <a:rPr lang="en-US" altLang="ja-JP" sz="2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nowledge </a:t>
            </a:r>
            <a:r>
              <a:rPr lang="en-US" altLang="ja-JP" sz="2400" dirty="0">
                <a:latin typeface="Times New Roman" pitchFamily="18" charset="0"/>
                <a:cs typeface="Times New Roman" pitchFamily="18" charset="0"/>
              </a:rPr>
              <a:t>related to vaccination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コンテンツ プレースホル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3420802607"/>
              </p:ext>
            </p:extLst>
          </p:nvPr>
        </p:nvGraphicFramePr>
        <p:xfrm>
          <a:off x="251520" y="1600202"/>
          <a:ext cx="8640960" cy="445178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6409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4874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kern="12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tement/Question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87460">
                <a:tc>
                  <a:txBody>
                    <a:bodyPr/>
                    <a:lstStyle/>
                    <a:p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 Because hepatitis B virus is very infectious, infection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can occur </a:t>
                      </a:r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unknowingly.</a:t>
                      </a:r>
                    </a:p>
                    <a:p>
                      <a:r>
                        <a:rPr kumimoji="1" lang="en-US" altLang="ja-JP" sz="1400" dirty="0" smtClean="0">
                          <a:solidFill>
                            <a:srgbClr val="FF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    </a:t>
                      </a:r>
                      <a:endParaRPr kumimoji="1" lang="ja-JP" altLang="en-US" sz="1400" b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76124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 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80–90% of infants infected with the hepatitis B virus during the first year of life develop chronic infections.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7612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 The rotavirus vaccine has a limited period for inoculation (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he first dose of r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tavirus 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accine is most effective if it is given before a child is 15 weeks of age. Children should receive all doses of the rotavirus vaccine before they turn 8 months old.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7612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 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 Since the risk of suffering from bacterial meningitis is high after 6 months of age,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t is necessary to </a:t>
                      </a:r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rt</a:t>
                      </a:r>
                      <a:r>
                        <a:rPr kumimoji="1" lang="en-US" altLang="ja-JP" sz="14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ccination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with 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ib and PCV13 vaccines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mmediately after a child turns 6 months of age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.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16244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 In the case of serious side effects due to simultaneous vaccination with 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outine vaccines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nd 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o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ional vaccines, in principle, the R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elief System for Injury to Health with </a:t>
                      </a:r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o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ional </a:t>
                      </a:r>
                      <a:r>
                        <a:rPr kumimoji="1" lang="en-US" altLang="ja-JP" sz="1400" b="0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Vaccination</a:t>
                      </a:r>
                      <a:r>
                        <a:rPr kumimoji="1" lang="en-US" altLang="ja-JP" sz="1400" b="0" i="0" kern="1200" baseline="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arbitrary inoculation) is applied. 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ja-JP" sz="2800" b="1" dirty="0" smtClean="0"/>
              <a:t>Table S3.</a:t>
            </a:r>
            <a:r>
              <a:rPr lang="en-US" altLang="ja-JP" sz="2800" b="1" dirty="0" smtClean="0">
                <a:latin typeface="Times New Roman"/>
                <a:ea typeface="ＭＳ 明朝"/>
              </a:rPr>
              <a:t/>
            </a:r>
            <a:br>
              <a:rPr lang="en-US" altLang="ja-JP" sz="2800" b="1" dirty="0" smtClean="0">
                <a:latin typeface="Times New Roman"/>
                <a:ea typeface="ＭＳ 明朝"/>
              </a:rPr>
            </a:br>
            <a:r>
              <a:rPr lang="en-US" altLang="ja-JP" sz="2800" dirty="0" smtClean="0">
                <a:latin typeface="Times New Roman"/>
                <a:ea typeface="ＭＳ 明朝"/>
              </a:rPr>
              <a:t>Questions for</a:t>
            </a:r>
            <a:r>
              <a:rPr lang="ja-JP" altLang="en-US" sz="2800" dirty="0">
                <a:latin typeface="Times New Roman"/>
                <a:ea typeface="ＭＳ 明朝"/>
              </a:rPr>
              <a:t>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lth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teracy regarding vaccination of children</a:t>
            </a:r>
            <a:endParaRPr kumimoji="1" lang="ja-JP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コンテンツ プレースホル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3222237548"/>
              </p:ext>
            </p:extLst>
          </p:nvPr>
        </p:nvGraphicFramePr>
        <p:xfrm>
          <a:off x="1115616" y="1600202"/>
          <a:ext cx="7344816" cy="450734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344816"/>
              </a:tblGrid>
              <a:tr h="4874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kern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Statement/Question</a:t>
                      </a:r>
                      <a:endParaRPr kumimoji="1" lang="ja-JP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48746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he items asked whether you would be able to </a:t>
                      </a:r>
                      <a:endParaRPr kumimoji="1" lang="ja-JP" altLang="en-US" sz="1400" b="1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487460">
                <a:tc>
                  <a:txBody>
                    <a:bodyPr/>
                    <a:lstStyle/>
                    <a:p>
                      <a:r>
                        <a:rPr kumimoji="1" lang="en-US" altLang="ja-JP" sz="1400" dirty="0" smtClean="0">
                          <a:latin typeface="Times New Roman" pitchFamily="18" charset="0"/>
                          <a:cs typeface="Times New Roman" pitchFamily="18" charset="0"/>
                        </a:rPr>
                        <a:t>1.</a:t>
                      </a:r>
                      <a:r>
                        <a:rPr kumimoji="1" lang="ja-JP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ollect your child's vaccination-related information from various sources.</a:t>
                      </a:r>
                      <a:endParaRPr kumimoji="1" lang="ja-JP" altLang="en-US" sz="1400" b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76124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 </a:t>
                      </a: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extract the information you wanted.</a:t>
                      </a:r>
                      <a:endParaRPr kumimoji="1" lang="ja-JP" altLang="en-US" sz="1400" b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761241">
                <a:tc>
                  <a:txBody>
                    <a:bodyPr/>
                    <a:lstStyle/>
                    <a:p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 </a:t>
                      </a: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understand and communicate the obtained information.</a:t>
                      </a:r>
                      <a:endParaRPr kumimoji="1" lang="ja-JP" altLang="en-US" sz="1400" b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761241">
                <a:tc>
                  <a:txBody>
                    <a:bodyPr/>
                    <a:lstStyle/>
                    <a:p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 </a:t>
                      </a: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onsider the credibility of the information issues.</a:t>
                      </a:r>
                      <a:endParaRPr kumimoji="1" lang="en-US" altLang="ja-JP" sz="1400" b="0" i="0" kern="1200" dirty="0" smtClean="0">
                        <a:solidFill>
                          <a:srgbClr val="FF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761241">
                <a:tc>
                  <a:txBody>
                    <a:bodyPr/>
                    <a:lstStyle/>
                    <a:p>
                      <a:r>
                        <a:rPr kumimoji="1" lang="en-US" altLang="ja-JP" sz="14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 </a:t>
                      </a:r>
                      <a:r>
                        <a:rPr kumimoji="1" lang="en-US" altLang="ja-JP" sz="14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ake decisions based on the information, specifically in the context of on your child's vaccination-related issues.</a:t>
                      </a:r>
                      <a:endParaRPr kumimoji="1" lang="ja-JP" altLang="en-US" sz="1400" b="1" dirty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287611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512" y="44624"/>
            <a:ext cx="8856984" cy="576064"/>
          </a:xfrm>
        </p:spPr>
        <p:txBody>
          <a:bodyPr>
            <a:noAutofit/>
          </a:bodyPr>
          <a:lstStyle/>
          <a:p>
            <a:r>
              <a:rPr lang="en-US" altLang="ja-JP" sz="2000" b="1" dirty="0" smtClean="0"/>
              <a:t>Table S4.</a:t>
            </a:r>
            <a:r>
              <a:rPr lang="en-US" altLang="ja-JP" sz="2000" b="1" dirty="0">
                <a:latin typeface="Times New Roman" pitchFamily="18" charset="0"/>
                <a:ea typeface="ＭＳ 明朝"/>
                <a:cs typeface="Times New Roman" pitchFamily="18" charset="0"/>
              </a:rPr>
              <a:t/>
            </a:r>
            <a:br>
              <a:rPr lang="en-US" altLang="ja-JP" sz="2000" b="1" dirty="0">
                <a:latin typeface="Times New Roman" pitchFamily="18" charset="0"/>
                <a:ea typeface="ＭＳ 明朝"/>
                <a:cs typeface="Times New Roman" pitchFamily="18" charset="0"/>
              </a:rPr>
            </a:br>
            <a:r>
              <a:rPr lang="en-US" altLang="ja-JP" sz="2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1" lang="en-US" altLang="ja-JP" sz="2000" dirty="0">
                <a:latin typeface="Times New Roman" pitchFamily="18" charset="0"/>
                <a:cs typeface="Times New Roman" pitchFamily="18" charset="0"/>
              </a:rPr>
              <a:t>Attitudes and beliefs about vaccine-preventable diseases and vaccination</a:t>
            </a:r>
            <a:endParaRPr kumimoji="1" lang="ja-JP" altLang="en-US" sz="3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コンテンツ プレースホル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1547271218"/>
              </p:ext>
            </p:extLst>
          </p:nvPr>
        </p:nvGraphicFramePr>
        <p:xfrm>
          <a:off x="755576" y="754936"/>
          <a:ext cx="7632848" cy="57704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3284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32607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baseline="0" dirty="0">
                          <a:latin typeface="Times New Roman" pitchFamily="18" charset="0"/>
                          <a:cs typeface="Times New Roman" pitchFamily="18" charset="0"/>
                        </a:rPr>
                        <a:t>Statement/Question</a:t>
                      </a:r>
                      <a:endParaRPr kumimoji="1" lang="ja-JP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32453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rceived severity (H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42900" lvl="0" indent="-342900">
                        <a:buFont typeface="+mj-lt"/>
                        <a:buNone/>
                      </a:pPr>
                      <a:r>
                        <a:rPr kumimoji="1" lang="en-US" altLang="ja-JP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1.</a:t>
                      </a:r>
                      <a:r>
                        <a:rPr kumimoji="1" lang="ja-JP" altLang="ja-JP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Vaccine-preventabl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diseases are serious diseas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42900" lvl="0" indent="-342900">
                        <a:buFont typeface="+mj-lt"/>
                        <a:buNone/>
                      </a:pP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2. Vaccine-preventabl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disease are serious diseases for babi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1304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rceived susceptibility (H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3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My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baby is not very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likely to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contract vaccine-preventable diseas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94898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rceived benefits (H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4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Th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vaccines for babies will prevent my baby from getting sick with vaccine-preventable diseas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5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f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my baby receives the vaccines, it will help protect my friends and family from getting the flu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.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ccine will prevent my baby from missin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ay-care because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t prevents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ccine-preventable diseases</a:t>
                      </a:r>
                      <a:endParaRPr lang="ja-JP" sz="1400" kern="1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7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f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my baby receives the vaccines, it will prevent us (parents) from missing work to take care of my baby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11102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rceived barriers (H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8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Th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vaccines will make my baby sick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9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Th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vaccines do not prevent vaccine-preventable diseas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0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Getting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the vaccines costs too much money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1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will feel uncomfortable because receiving the vaccines is painful or uncomfortable for my baby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254000" indent="-2540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2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t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is tough to watch my baby in pain the day after a vaccination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55513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Self-efficacy (H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17500" indent="-317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3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feel comfortable getting vaccines for my baby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254000" indent="-2540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4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would feel comfortable asking my husband/partner to take my baby to get the vaccin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0861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rceived behavioral control (IBM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254000" indent="-2540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5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have control over whether or not my baby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gets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the vaccines 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925855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Social norm (injunctive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6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Most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ople important to me think I should get my baby vaccinated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7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The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ediatricians think my baby should get the vaccin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8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My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parents think my baby should get the vaccines 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190500" indent="-190500"/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19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My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friends think my baby should get the vaccin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58311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Social norm (descriptive)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20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I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know other people my age who gave their baby the vaccin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21. </a:t>
                      </a:r>
                      <a:r>
                        <a:rPr lang="en-US" sz="1200" kern="100" dirty="0" smtClean="0">
                          <a:latin typeface="Times New Roman" pitchFamily="18" charset="0"/>
                          <a:cs typeface="Times New Roman" pitchFamily="18" charset="0"/>
                        </a:rPr>
                        <a:t>Most </a:t>
                      </a:r>
                      <a:r>
                        <a:rPr lang="en-US" sz="1200" kern="100" dirty="0">
                          <a:latin typeface="Times New Roman" pitchFamily="18" charset="0"/>
                          <a:cs typeface="Times New Roman" pitchFamily="18" charset="0"/>
                        </a:rPr>
                        <a:t>of my friends gave their baby the vaccines</a:t>
                      </a:r>
                      <a:endParaRPr lang="ja-JP" sz="1400" kern="1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755576" y="6497960"/>
            <a:ext cx="4248472" cy="3600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fontAlgn="ctr"/>
            <a:r>
              <a:rPr lang="en-US" altLang="ja-JP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HBM: Health Belief Model, IBM: Integrated Behavioral Model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865640664"/>
              </p:ext>
            </p:extLst>
          </p:nvPr>
        </p:nvGraphicFramePr>
        <p:xfrm>
          <a:off x="467544" y="1268760"/>
          <a:ext cx="8064897" cy="5237826"/>
        </p:xfrm>
        <a:graphic>
          <a:graphicData uri="http://schemas.openxmlformats.org/drawingml/2006/table">
            <a:tbl>
              <a:tblPr/>
              <a:tblGrid>
                <a:gridCol w="408582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15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914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7914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529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4477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70916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347584">
                <a:tc gridSpan="6"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9408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e-study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ost-study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8526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Knowledge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asi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knowledge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</a:t>
                      </a:r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1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Advanced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owledge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0.6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3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titudes and beliefs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Perceived severity (HBM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0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Perceived susceptibility (HBM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858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Perceived benefits (HBM) 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0.84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Perceived barriers (HBM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5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Self-efficacy (HBM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4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Perceived behavioral control (IBM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171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Social norm (injunctive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0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444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Social norm (descriptive) 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ja-JP" altLang="en-US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2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378902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ealth literacy regarding vaccination of childre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latin typeface="Times New Roman" pitchFamily="18" charset="0"/>
                          <a:cs typeface="Times New Roman" pitchFamily="18" charset="0"/>
                        </a:rPr>
                        <a:t>0.86</a:t>
                      </a:r>
                      <a:endParaRPr lang="ja-JP" altLang="en-US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347584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BM: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alth Belief Model, IBM: Integrated Behavioral Model</a:t>
                      </a: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410" marR="7410" marT="74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</a:tbl>
          </a:graphicData>
        </a:graphic>
      </p:graphicFrame>
      <p:sp>
        <p:nvSpPr>
          <p:cNvPr id="5" name="タイトル 4"/>
          <p:cNvSpPr>
            <a:spLocks noGrp="1"/>
          </p:cNvSpPr>
          <p:nvPr>
            <p:ph type="title"/>
          </p:nvPr>
        </p:nvSpPr>
        <p:spPr>
          <a:xfrm>
            <a:off x="539552" y="158006"/>
            <a:ext cx="7056784" cy="1254770"/>
          </a:xfrm>
          <a:ln>
            <a:noFill/>
          </a:ln>
        </p:spPr>
        <p:txBody>
          <a:bodyPr>
            <a:noAutofit/>
          </a:bodyPr>
          <a:lstStyle/>
          <a:p>
            <a:r>
              <a:rPr lang="en-US" altLang="ja-JP" sz="2400" b="1" smtClean="0"/>
              <a:t>Table S5.</a:t>
            </a:r>
            <a:r>
              <a:rPr lang="en-US" altLang="ja-JP" sz="2400" b="1" dirty="0">
                <a:latin typeface="Times New Roman" pitchFamily="18" charset="0"/>
                <a:ea typeface="ＭＳ 明朝"/>
                <a:cs typeface="Times New Roman" pitchFamily="18" charset="0"/>
              </a:rPr>
              <a:t/>
            </a:r>
            <a:br>
              <a:rPr lang="en-US" altLang="ja-JP" sz="2400" b="1" dirty="0">
                <a:latin typeface="Times New Roman" pitchFamily="18" charset="0"/>
                <a:ea typeface="ＭＳ 明朝"/>
                <a:cs typeface="Times New Roman" pitchFamily="18" charset="0"/>
              </a:rPr>
            </a:b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consistency (Cronbach α)</a:t>
            </a:r>
            <a:r>
              <a: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knowledge, attitudes and beliefs scores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50682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98</TotalTime>
  <Words>920</Words>
  <Application>Microsoft Office PowerPoint</Application>
  <PresentationFormat>画面に合わせる (4:3)</PresentationFormat>
  <Paragraphs>141</Paragraphs>
  <Slides>6</Slides>
  <Notes>6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7" baseType="lpstr">
      <vt:lpstr>Office テーマ</vt:lpstr>
      <vt:lpstr>スライド 1</vt:lpstr>
      <vt:lpstr>Table S1.  Questions for basic knowledge related to vaccination</vt:lpstr>
      <vt:lpstr>Table S2. Questions for advanced knowledge related to vaccination</vt:lpstr>
      <vt:lpstr>Table S3. Questions for health literacy regarding vaccination of children</vt:lpstr>
      <vt:lpstr>Table S4.  Attitudes and beliefs about vaccine-preventable diseases and vaccination</vt:lpstr>
      <vt:lpstr>Table S5. Internal consistency (Cronbach α) for knowledge, attitudes and beliefs score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atements and Questions Used to Evaluate Change in Attitudes and Beliefs Among Study Participants</dc:title>
  <dc:creator>asaitoh</dc:creator>
  <cp:lastModifiedBy>user</cp:lastModifiedBy>
  <cp:revision>204</cp:revision>
  <dcterms:created xsi:type="dcterms:W3CDTF">2012-09-23T14:05:09Z</dcterms:created>
  <dcterms:modified xsi:type="dcterms:W3CDTF">2019-11-02T06:39:22Z</dcterms:modified>
</cp:coreProperties>
</file>